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2" d="100"/>
          <a:sy n="72" d="100"/>
        </p:scale>
        <p:origin x="-1242" y="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AD2C0-1A8B-4EA1-8E6B-54B5C84CDFE9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F96C4-9C6B-4AAC-9948-9CB9928A40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9074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AD2C0-1A8B-4EA1-8E6B-54B5C84CDFE9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F96C4-9C6B-4AAC-9948-9CB9928A40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0376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AD2C0-1A8B-4EA1-8E6B-54B5C84CDFE9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F96C4-9C6B-4AAC-9948-9CB9928A40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298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AD2C0-1A8B-4EA1-8E6B-54B5C84CDFE9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F96C4-9C6B-4AAC-9948-9CB9928A40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984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AD2C0-1A8B-4EA1-8E6B-54B5C84CDFE9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F96C4-9C6B-4AAC-9948-9CB9928A40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475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AD2C0-1A8B-4EA1-8E6B-54B5C84CDFE9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F96C4-9C6B-4AAC-9948-9CB9928A40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25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AD2C0-1A8B-4EA1-8E6B-54B5C84CDFE9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F96C4-9C6B-4AAC-9948-9CB9928A40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365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AD2C0-1A8B-4EA1-8E6B-54B5C84CDFE9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F96C4-9C6B-4AAC-9948-9CB9928A40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439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AD2C0-1A8B-4EA1-8E6B-54B5C84CDFE9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F96C4-9C6B-4AAC-9948-9CB9928A40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1883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AD2C0-1A8B-4EA1-8E6B-54B5C84CDFE9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F96C4-9C6B-4AAC-9948-9CB9928A40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294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AD2C0-1A8B-4EA1-8E6B-54B5C84CDFE9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F96C4-9C6B-4AAC-9948-9CB9928A40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2494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AAD2C0-1A8B-4EA1-8E6B-54B5C84CDFE9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EF96C4-9C6B-4AAC-9948-9CB9928A40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176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4624525"/>
              </p:ext>
            </p:extLst>
          </p:nvPr>
        </p:nvGraphicFramePr>
        <p:xfrm>
          <a:off x="457200" y="1219200"/>
          <a:ext cx="8382003" cy="5184675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197429"/>
                <a:gridCol w="1197429"/>
                <a:gridCol w="1197429"/>
                <a:gridCol w="1197429"/>
                <a:gridCol w="1197429"/>
                <a:gridCol w="1197429"/>
                <a:gridCol w="1197429"/>
              </a:tblGrid>
              <a:tr h="63875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diment section</a:t>
                      </a:r>
                      <a:endParaRPr lang="en-US" sz="14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w bases</a:t>
                      </a:r>
                      <a:endParaRPr lang="en-US" sz="1400" b="1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C bases</a:t>
                      </a:r>
                      <a:endParaRPr lang="en-US" sz="14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change</a:t>
                      </a:r>
                      <a:endParaRPr lang="en-US" sz="1400" b="1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w reads</a:t>
                      </a:r>
                      <a:endParaRPr lang="en-US" sz="1400" b="1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C reads</a:t>
                      </a:r>
                      <a:endParaRPr lang="en-US" sz="1400" b="1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change</a:t>
                      </a:r>
                      <a:endParaRPr lang="en-US" sz="14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IID-1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8E + 0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3E + 0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7.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886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864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9.3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IID-1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6E + 0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2E + 0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7.6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008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024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9.2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IID-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79894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09484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23.2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221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38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27.47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IID-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83081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57067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5.6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599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997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7.0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IID-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33733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43640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7.8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36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44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10.7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IID-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32276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94755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6.2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627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448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8.6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IID-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38298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90537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10.4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41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05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13.1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D-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39890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70557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5.9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134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03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8.0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D-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15295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77156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28.4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354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60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33.8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D-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78314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70309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19.7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34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03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24.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D-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95626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81163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24.1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071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18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28.5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D-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85970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77600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9.8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795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701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11.7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D-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08070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13319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6.1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734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294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7.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D-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7E + 0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E + 0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9.0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349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021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14.5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79545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79328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7.0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393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04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8.6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41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47336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79244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8.6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963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415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11.0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152400" y="152400"/>
            <a:ext cx="88392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3. List of sediments used for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samples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llection with QC values calculated post quality control for raw sequenced reads. Data available in NCBI SRA under PRJNA299097 and PRJNA193416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86391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59</Words>
  <Application>Microsoft Office PowerPoint</Application>
  <PresentationFormat>On-screen Show (4:3)</PresentationFormat>
  <Paragraphs>1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ri</dc:creator>
  <cp:lastModifiedBy>Sheri</cp:lastModifiedBy>
  <cp:revision>5</cp:revision>
  <dcterms:created xsi:type="dcterms:W3CDTF">2023-03-20T21:15:46Z</dcterms:created>
  <dcterms:modified xsi:type="dcterms:W3CDTF">2023-03-30T13:52:45Z</dcterms:modified>
</cp:coreProperties>
</file>